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35999738" cy="28800425"/>
  <p:notesSz cx="6858000" cy="9144000"/>
  <p:defaultTextStyle>
    <a:defPPr>
      <a:defRPr lang="en-US"/>
    </a:defPPr>
    <a:lvl1pPr marL="0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1pPr>
    <a:lvl2pPr marL="1851431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2pPr>
    <a:lvl3pPr marL="3702863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3pPr>
    <a:lvl4pPr marL="5554294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4pPr>
    <a:lvl5pPr marL="7405726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5pPr>
    <a:lvl6pPr marL="9257157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6pPr>
    <a:lvl7pPr marL="11108588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7pPr>
    <a:lvl8pPr marL="12960020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8pPr>
    <a:lvl9pPr marL="14811451" algn="l" defTabSz="3702863" rtl="0" eaLnBrk="1" latinLnBrk="0" hangingPunct="1">
      <a:defRPr sz="728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071" userDrawn="1">
          <p15:clr>
            <a:srgbClr val="A4A3A4"/>
          </p15:clr>
        </p15:guide>
        <p15:guide id="2" pos="113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21" d="100"/>
          <a:sy n="21" d="100"/>
        </p:scale>
        <p:origin x="1464" y="91"/>
      </p:cViewPr>
      <p:guideLst>
        <p:guide orient="horz" pos="9071"/>
        <p:guide pos="113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699981" y="8946801"/>
            <a:ext cx="30599777" cy="6173424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5399961" y="16320241"/>
            <a:ext cx="25199817" cy="7360109"/>
          </a:xfrm>
        </p:spPr>
        <p:txBody>
          <a:bodyPr/>
          <a:lstStyle>
            <a:lvl1pPr marL="0" indent="0" algn="ctr">
              <a:buNone/>
              <a:defRPr/>
            </a:lvl1pPr>
            <a:lvl2pPr marL="1799996" indent="0" algn="ctr">
              <a:buNone/>
              <a:defRPr/>
            </a:lvl2pPr>
            <a:lvl3pPr marL="3599993" indent="0" algn="ctr">
              <a:buNone/>
              <a:defRPr/>
            </a:lvl3pPr>
            <a:lvl4pPr marL="5399989" indent="0" algn="ctr">
              <a:buNone/>
              <a:defRPr/>
            </a:lvl4pPr>
            <a:lvl5pPr marL="7199986" indent="0" algn="ctr">
              <a:buNone/>
              <a:defRPr/>
            </a:lvl5pPr>
            <a:lvl6pPr marL="8999982" indent="0" algn="ctr">
              <a:buNone/>
              <a:defRPr/>
            </a:lvl6pPr>
            <a:lvl7pPr marL="10799978" indent="0" algn="ctr">
              <a:buNone/>
              <a:defRPr/>
            </a:lvl7pPr>
            <a:lvl8pPr marL="12599975" indent="0" algn="ctr">
              <a:buNone/>
              <a:defRPr/>
            </a:lvl8pPr>
            <a:lvl9pPr marL="14399971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377DFEC-27FB-4FFC-AD4C-D0BF7CDF1F2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9902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7F8FC91-247A-4FF1-8367-E89D5075F76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5753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6099810" y="1153355"/>
            <a:ext cx="8099941" cy="2457369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1799987" y="1153355"/>
            <a:ext cx="23699828" cy="2457369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07A4533-A01C-4A66-A6F0-F6C1B6FDAD35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9119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DD4C6A3-13E2-4428-AEE0-6AFB7BB9F02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4249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43731" y="18506942"/>
            <a:ext cx="30599777" cy="5720084"/>
          </a:xfrm>
        </p:spPr>
        <p:txBody>
          <a:bodyPr anchor="t"/>
          <a:lstStyle>
            <a:lvl1pPr algn="l">
              <a:defRPr sz="15748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843731" y="12206851"/>
            <a:ext cx="30599777" cy="6300091"/>
          </a:xfrm>
        </p:spPr>
        <p:txBody>
          <a:bodyPr anchor="b"/>
          <a:lstStyle>
            <a:lvl1pPr marL="0" indent="0">
              <a:buNone/>
              <a:defRPr sz="7874"/>
            </a:lvl1pPr>
            <a:lvl2pPr marL="1799996" indent="0">
              <a:buNone/>
              <a:defRPr sz="7087"/>
            </a:lvl2pPr>
            <a:lvl3pPr marL="3599993" indent="0">
              <a:buNone/>
              <a:defRPr sz="6299"/>
            </a:lvl3pPr>
            <a:lvl4pPr marL="5399989" indent="0">
              <a:buNone/>
              <a:defRPr sz="5512"/>
            </a:lvl4pPr>
            <a:lvl5pPr marL="7199986" indent="0">
              <a:buNone/>
              <a:defRPr sz="5512"/>
            </a:lvl5pPr>
            <a:lvl6pPr marL="8999982" indent="0">
              <a:buNone/>
              <a:defRPr sz="5512"/>
            </a:lvl6pPr>
            <a:lvl7pPr marL="10799978" indent="0">
              <a:buNone/>
              <a:defRPr sz="5512"/>
            </a:lvl7pPr>
            <a:lvl8pPr marL="12599975" indent="0">
              <a:buNone/>
              <a:defRPr sz="5512"/>
            </a:lvl8pPr>
            <a:lvl9pPr marL="14399971" indent="0">
              <a:buNone/>
              <a:defRPr sz="551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41AD3D1-09BF-4654-8616-5407C6937B67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7506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1799987" y="6720101"/>
            <a:ext cx="15899884" cy="19006949"/>
          </a:xfrm>
        </p:spPr>
        <p:txBody>
          <a:bodyPr/>
          <a:lstStyle>
            <a:lvl1pPr>
              <a:defRPr sz="11024"/>
            </a:lvl1pPr>
            <a:lvl2pPr>
              <a:defRPr sz="9449"/>
            </a:lvl2pPr>
            <a:lvl3pPr>
              <a:defRPr sz="7874"/>
            </a:lvl3pPr>
            <a:lvl4pPr>
              <a:defRPr sz="7087"/>
            </a:lvl4pPr>
            <a:lvl5pPr>
              <a:defRPr sz="7087"/>
            </a:lvl5pPr>
            <a:lvl6pPr>
              <a:defRPr sz="7087"/>
            </a:lvl6pPr>
            <a:lvl7pPr>
              <a:defRPr sz="7087"/>
            </a:lvl7pPr>
            <a:lvl8pPr>
              <a:defRPr sz="7087"/>
            </a:lvl8pPr>
            <a:lvl9pPr>
              <a:defRPr sz="708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8299867" y="6720101"/>
            <a:ext cx="15899884" cy="19006949"/>
          </a:xfrm>
        </p:spPr>
        <p:txBody>
          <a:bodyPr/>
          <a:lstStyle>
            <a:lvl1pPr>
              <a:defRPr sz="11024"/>
            </a:lvl1pPr>
            <a:lvl2pPr>
              <a:defRPr sz="9449"/>
            </a:lvl2pPr>
            <a:lvl3pPr>
              <a:defRPr sz="7874"/>
            </a:lvl3pPr>
            <a:lvl4pPr>
              <a:defRPr sz="7087"/>
            </a:lvl4pPr>
            <a:lvl5pPr>
              <a:defRPr sz="7087"/>
            </a:lvl5pPr>
            <a:lvl6pPr>
              <a:defRPr sz="7087"/>
            </a:lvl6pPr>
            <a:lvl7pPr>
              <a:defRPr sz="7087"/>
            </a:lvl7pPr>
            <a:lvl8pPr>
              <a:defRPr sz="7087"/>
            </a:lvl8pPr>
            <a:lvl9pPr>
              <a:defRPr sz="708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A96F60D-4CB3-4977-9510-DC736CC44F3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1662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1799987" y="6446764"/>
            <a:ext cx="15906136" cy="2686704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1799987" y="9133468"/>
            <a:ext cx="15906136" cy="16593580"/>
          </a:xfrm>
        </p:spPr>
        <p:txBody>
          <a:bodyPr/>
          <a:lstStyle>
            <a:lvl1pPr>
              <a:defRPr sz="9449"/>
            </a:lvl1pPr>
            <a:lvl2pPr>
              <a:defRPr sz="7874"/>
            </a:lvl2pPr>
            <a:lvl3pPr>
              <a:defRPr sz="7087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18287369" y="6446764"/>
            <a:ext cx="15912384" cy="2686704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18287369" y="9133468"/>
            <a:ext cx="15912384" cy="16593580"/>
          </a:xfrm>
        </p:spPr>
        <p:txBody>
          <a:bodyPr/>
          <a:lstStyle>
            <a:lvl1pPr>
              <a:defRPr sz="9449"/>
            </a:lvl1pPr>
            <a:lvl2pPr>
              <a:defRPr sz="7874"/>
            </a:lvl2pPr>
            <a:lvl3pPr>
              <a:defRPr sz="7087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7059EA9-4A08-48A9-8EC1-928073AC7D57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4353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AA740A9-FD4B-4CCE-BB25-170A39F8F55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4169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983353F-7D6F-41DC-8DD3-CEA6F840124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2567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9989" y="1146684"/>
            <a:ext cx="11843666" cy="4880072"/>
          </a:xfrm>
        </p:spPr>
        <p:txBody>
          <a:bodyPr anchor="b"/>
          <a:lstStyle>
            <a:lvl1pPr algn="l">
              <a:defRPr sz="7874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14074897" y="1146686"/>
            <a:ext cx="20124854" cy="24580365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9989" y="6026758"/>
            <a:ext cx="11843666" cy="19700293"/>
          </a:xfrm>
        </p:spPr>
        <p:txBody>
          <a:bodyPr/>
          <a:lstStyle>
            <a:lvl1pPr marL="0" indent="0">
              <a:buNone/>
              <a:defRPr sz="5512"/>
            </a:lvl1pPr>
            <a:lvl2pPr marL="1799996" indent="0">
              <a:buNone/>
              <a:defRPr sz="4724"/>
            </a:lvl2pPr>
            <a:lvl3pPr marL="3599993" indent="0">
              <a:buNone/>
              <a:defRPr sz="3937"/>
            </a:lvl3pPr>
            <a:lvl4pPr marL="5399989" indent="0">
              <a:buNone/>
              <a:defRPr sz="3543"/>
            </a:lvl4pPr>
            <a:lvl5pPr marL="7199986" indent="0">
              <a:buNone/>
              <a:defRPr sz="3543"/>
            </a:lvl5pPr>
            <a:lvl6pPr marL="8999982" indent="0">
              <a:buNone/>
              <a:defRPr sz="3543"/>
            </a:lvl6pPr>
            <a:lvl7pPr marL="10799978" indent="0">
              <a:buNone/>
              <a:defRPr sz="3543"/>
            </a:lvl7pPr>
            <a:lvl8pPr marL="12599975" indent="0">
              <a:buNone/>
              <a:defRPr sz="3543"/>
            </a:lvl8pPr>
            <a:lvl9pPr marL="14399971" indent="0">
              <a:buNone/>
              <a:defRPr sz="354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6CF7B4A-E093-4791-A9B5-E7E34EC78E9D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5807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056201" y="20160298"/>
            <a:ext cx="21599843" cy="2380037"/>
          </a:xfrm>
        </p:spPr>
        <p:txBody>
          <a:bodyPr anchor="b"/>
          <a:lstStyle>
            <a:lvl1pPr algn="l">
              <a:defRPr sz="7874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7056201" y="2573371"/>
            <a:ext cx="21599843" cy="17280255"/>
          </a:xfrm>
        </p:spPr>
        <p:txBody>
          <a:bodyPr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7056201" y="22540335"/>
            <a:ext cx="21599843" cy="3380048"/>
          </a:xfrm>
        </p:spPr>
        <p:txBody>
          <a:bodyPr/>
          <a:lstStyle>
            <a:lvl1pPr marL="0" indent="0">
              <a:buNone/>
              <a:defRPr sz="5512"/>
            </a:lvl1pPr>
            <a:lvl2pPr marL="1799996" indent="0">
              <a:buNone/>
              <a:defRPr sz="4724"/>
            </a:lvl2pPr>
            <a:lvl3pPr marL="3599993" indent="0">
              <a:buNone/>
              <a:defRPr sz="3937"/>
            </a:lvl3pPr>
            <a:lvl4pPr marL="5399989" indent="0">
              <a:buNone/>
              <a:defRPr sz="3543"/>
            </a:lvl4pPr>
            <a:lvl5pPr marL="7199986" indent="0">
              <a:buNone/>
              <a:defRPr sz="3543"/>
            </a:lvl5pPr>
            <a:lvl6pPr marL="8999982" indent="0">
              <a:buNone/>
              <a:defRPr sz="3543"/>
            </a:lvl6pPr>
            <a:lvl7pPr marL="10799978" indent="0">
              <a:buNone/>
              <a:defRPr sz="3543"/>
            </a:lvl7pPr>
            <a:lvl8pPr marL="12599975" indent="0">
              <a:buNone/>
              <a:defRPr sz="3543"/>
            </a:lvl8pPr>
            <a:lvl9pPr marL="14399971" indent="0">
              <a:buNone/>
              <a:defRPr sz="354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838B56B-32D3-4AAC-9E8C-9FA73808CB29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0533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799987" y="1153352"/>
            <a:ext cx="32399764" cy="48000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799987" y="6720101"/>
            <a:ext cx="32399764" cy="190069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1799987" y="26227053"/>
            <a:ext cx="8399939" cy="2000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5512"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2299911" y="26227053"/>
            <a:ext cx="11399917" cy="2000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5512"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25799812" y="26227053"/>
            <a:ext cx="8399939" cy="20000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5512">
                <a:ea typeface="ＭＳ Ｐゴシック" pitchFamily="50" charset="-128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BA300E08-9C8B-4528-B47E-46206FDF7B17}" type="slidenum">
              <a:rPr lang="en-US" altLang="ja-JP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745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5pPr>
      <a:lvl6pPr marL="1799996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6pPr>
      <a:lvl7pPr marL="3599993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7pPr>
      <a:lvl8pPr marL="5399989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8pPr>
      <a:lvl9pPr marL="7199986" algn="ctr" rtl="0" fontAlgn="base">
        <a:spcBef>
          <a:spcPct val="0"/>
        </a:spcBef>
        <a:spcAft>
          <a:spcPct val="0"/>
        </a:spcAft>
        <a:defRPr sz="17323">
          <a:solidFill>
            <a:schemeClr val="tx2"/>
          </a:solidFill>
          <a:latin typeface="Arial" charset="0"/>
        </a:defRPr>
      </a:lvl9pPr>
    </p:titleStyle>
    <p:bodyStyle>
      <a:lvl1pPr marL="1349997" indent="-1349997" algn="l" rtl="0" eaLnBrk="0" fontAlgn="base" hangingPunct="0">
        <a:spcBef>
          <a:spcPct val="20000"/>
        </a:spcBef>
        <a:spcAft>
          <a:spcPct val="0"/>
        </a:spcAft>
        <a:buChar char="•"/>
        <a:defRPr sz="12598">
          <a:solidFill>
            <a:schemeClr val="tx1"/>
          </a:solidFill>
          <a:latin typeface="+mn-lt"/>
          <a:ea typeface="+mn-ea"/>
          <a:cs typeface="+mn-cs"/>
        </a:defRPr>
      </a:lvl1pPr>
      <a:lvl2pPr marL="2924994" indent="-1124998" algn="l" rtl="0" eaLnBrk="0" fontAlgn="base" hangingPunct="0">
        <a:spcBef>
          <a:spcPct val="20000"/>
        </a:spcBef>
        <a:spcAft>
          <a:spcPct val="0"/>
        </a:spcAft>
        <a:buChar char="–"/>
        <a:defRPr sz="11024">
          <a:solidFill>
            <a:schemeClr val="tx1"/>
          </a:solidFill>
          <a:latin typeface="+mn-lt"/>
        </a:defRPr>
      </a:lvl2pPr>
      <a:lvl3pPr marL="4499991" indent="-899998" algn="l" rtl="0" eaLnBrk="0" fontAlgn="base" hangingPunct="0">
        <a:spcBef>
          <a:spcPct val="20000"/>
        </a:spcBef>
        <a:spcAft>
          <a:spcPct val="0"/>
        </a:spcAft>
        <a:buChar char="•"/>
        <a:defRPr sz="9449">
          <a:solidFill>
            <a:schemeClr val="tx1"/>
          </a:solidFill>
          <a:latin typeface="+mn-lt"/>
        </a:defRPr>
      </a:lvl3pPr>
      <a:lvl4pPr marL="6299987" indent="-899998" algn="l" rtl="0" eaLnBrk="0" fontAlgn="base" hangingPunct="0">
        <a:spcBef>
          <a:spcPct val="20000"/>
        </a:spcBef>
        <a:spcAft>
          <a:spcPct val="0"/>
        </a:spcAft>
        <a:buChar char="–"/>
        <a:defRPr sz="7874">
          <a:solidFill>
            <a:schemeClr val="tx1"/>
          </a:solidFill>
          <a:latin typeface="+mn-lt"/>
        </a:defRPr>
      </a:lvl4pPr>
      <a:lvl5pPr marL="8099984" indent="-899998" algn="l" rtl="0" eaLnBrk="0" fontAlgn="base" hangingPunct="0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5pPr>
      <a:lvl6pPr marL="9899980" indent="-899998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6pPr>
      <a:lvl7pPr marL="11699977" indent="-899998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7pPr>
      <a:lvl8pPr marL="13499973" indent="-899998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8pPr>
      <a:lvl9pPr marL="15299969" indent="-899998" algn="l" rtl="0" fontAlgn="base">
        <a:spcBef>
          <a:spcPct val="20000"/>
        </a:spcBef>
        <a:spcAft>
          <a:spcPct val="0"/>
        </a:spcAft>
        <a:buChar char="»"/>
        <a:defRPr sz="7874">
          <a:solidFill>
            <a:schemeClr val="tx1"/>
          </a:solidFill>
          <a:latin typeface="+mn-lt"/>
        </a:defRPr>
      </a:lvl9pPr>
    </p:bodyStyle>
    <p:otherStyle>
      <a:defPPr>
        <a:defRPr lang="ja-JP"/>
      </a:defPPr>
      <a:lvl1pPr marL="0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kumimoji="1"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397669" y="2349876"/>
            <a:ext cx="34817017" cy="22337336"/>
            <a:chOff x="397669" y="2349876"/>
            <a:chExt cx="34817017" cy="22337336"/>
          </a:xfrm>
        </p:grpSpPr>
        <p:grpSp>
          <p:nvGrpSpPr>
            <p:cNvPr id="19458" name="グループ化 1"/>
            <p:cNvGrpSpPr>
              <a:grpSpLocks/>
            </p:cNvGrpSpPr>
            <p:nvPr/>
          </p:nvGrpSpPr>
          <p:grpSpPr bwMode="auto">
            <a:xfrm>
              <a:off x="397669" y="2349876"/>
              <a:ext cx="34799746" cy="22337336"/>
              <a:chOff x="0" y="-111686"/>
              <a:chExt cx="8839200" cy="5674286"/>
            </a:xfrm>
          </p:grpSpPr>
          <p:sp>
            <p:nvSpPr>
              <p:cNvPr id="19459" name="テキスト ボックス 6"/>
              <p:cNvSpPr txBox="1">
                <a:spLocks noChangeArrowheads="1"/>
              </p:cNvSpPr>
              <p:nvPr/>
            </p:nvSpPr>
            <p:spPr bwMode="auto">
              <a:xfrm>
                <a:off x="0" y="0"/>
                <a:ext cx="4606119" cy="3005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7087" b="1" dirty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S2</a:t>
                </a:r>
                <a:r>
                  <a:rPr kumimoji="1" lang="ja-JP" altLang="en-US" sz="7087" b="1" dirty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 </a:t>
                </a:r>
                <a:r>
                  <a:rPr kumimoji="1" lang="en-US" altLang="ja-JP" sz="7087" b="1" dirty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Fig. A                                                             B</a:t>
                </a:r>
              </a:p>
            </p:txBody>
          </p:sp>
          <p:pic>
            <p:nvPicPr>
              <p:cNvPr id="19460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4" t="12686" r="2274" b="12103"/>
              <a:stretch>
                <a:fillRect/>
              </a:stretch>
            </p:blipFill>
            <p:spPr bwMode="auto">
              <a:xfrm>
                <a:off x="5815013" y="3944938"/>
                <a:ext cx="3024187" cy="5826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461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4815"/>
              <a:stretch>
                <a:fillRect/>
              </a:stretch>
            </p:blipFill>
            <p:spPr bwMode="auto">
              <a:xfrm>
                <a:off x="5815013" y="3351213"/>
                <a:ext cx="3024187" cy="528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462" name="Picture 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5" t="15224" b="15359"/>
              <a:stretch>
                <a:fillRect/>
              </a:stretch>
            </p:blipFill>
            <p:spPr bwMode="auto">
              <a:xfrm>
                <a:off x="5815013" y="2093621"/>
                <a:ext cx="3024187" cy="5810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463" name="Picture 6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5" t="26537" b="14159"/>
              <a:stretch>
                <a:fillRect/>
              </a:stretch>
            </p:blipFill>
            <p:spPr bwMode="auto">
              <a:xfrm>
                <a:off x="5815013" y="4598988"/>
                <a:ext cx="3024187" cy="4810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464" name="テキスト ボックス 3"/>
              <p:cNvSpPr txBox="1">
                <a:spLocks noChangeArrowheads="1"/>
              </p:cNvSpPr>
              <p:nvPr/>
            </p:nvSpPr>
            <p:spPr bwMode="auto">
              <a:xfrm>
                <a:off x="4754563" y="2195220"/>
                <a:ext cx="947556" cy="2697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 dirty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E-cadherin</a:t>
                </a:r>
                <a:endParaRPr kumimoji="1" lang="en-US" altLang="ja-JP" sz="5512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65" name="テキスト ボックス 3"/>
              <p:cNvSpPr txBox="1">
                <a:spLocks noChangeArrowheads="1"/>
              </p:cNvSpPr>
              <p:nvPr/>
            </p:nvSpPr>
            <p:spPr bwMode="auto">
              <a:xfrm>
                <a:off x="5310188" y="4672013"/>
                <a:ext cx="405619" cy="23893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5512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er3</a:t>
                </a:r>
              </a:p>
            </p:txBody>
          </p:sp>
          <p:sp>
            <p:nvSpPr>
              <p:cNvPr id="19466" name="テキスト ボックス 11"/>
              <p:cNvSpPr txBox="1">
                <a:spLocks noChangeArrowheads="1"/>
              </p:cNvSpPr>
              <p:nvPr/>
            </p:nvSpPr>
            <p:spPr bwMode="auto">
              <a:xfrm>
                <a:off x="4752975" y="4095750"/>
                <a:ext cx="993159" cy="2697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Fibronectin</a:t>
                </a:r>
              </a:p>
            </p:txBody>
          </p:sp>
          <p:sp>
            <p:nvSpPr>
              <p:cNvPr id="19467" name="テキスト ボックス 5"/>
              <p:cNvSpPr txBox="1">
                <a:spLocks noChangeArrowheads="1"/>
              </p:cNvSpPr>
              <p:nvPr/>
            </p:nvSpPr>
            <p:spPr bwMode="auto">
              <a:xfrm>
                <a:off x="4878388" y="3446463"/>
                <a:ext cx="809820" cy="2697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Vimentin</a:t>
                </a:r>
                <a:endParaRPr kumimoji="1" lang="en-US" altLang="ja-JP" sz="5512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68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5565893" y="1458721"/>
                <a:ext cx="879239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69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5845142" y="1328545"/>
                <a:ext cx="1141480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0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6134420" y="1185670"/>
                <a:ext cx="1426524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-S1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1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6517007" y="1185671"/>
                <a:ext cx="1426524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-S2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2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6926582" y="1185671"/>
                <a:ext cx="1426524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-S3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3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7359176" y="1185670"/>
                <a:ext cx="1426524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-S4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4" name="テキスト ボックス 27"/>
              <p:cNvSpPr txBox="1">
                <a:spLocks noChangeArrowheads="1"/>
              </p:cNvSpPr>
              <p:nvPr/>
            </p:nvSpPr>
            <p:spPr bwMode="auto">
              <a:xfrm rot="16200000">
                <a:off x="7812407" y="1185671"/>
                <a:ext cx="1426524" cy="269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HCC4006ER-S5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5" name="テキスト ボックス 40"/>
              <p:cNvSpPr txBox="1">
                <a:spLocks noChangeArrowheads="1"/>
              </p:cNvSpPr>
              <p:nvPr/>
            </p:nvSpPr>
            <p:spPr bwMode="auto">
              <a:xfrm>
                <a:off x="5040313" y="5199063"/>
                <a:ext cx="618566" cy="2697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β-actin</a:t>
                </a:r>
                <a:endParaRPr kumimoji="1" lang="ja-JP" altLang="en-US" sz="6299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sp>
            <p:nvSpPr>
              <p:cNvPr id="19477" name="テキスト ボックス 21"/>
              <p:cNvSpPr txBox="1">
                <a:spLocks noChangeArrowheads="1"/>
              </p:cNvSpPr>
              <p:nvPr/>
            </p:nvSpPr>
            <p:spPr bwMode="auto">
              <a:xfrm>
                <a:off x="76200" y="5254625"/>
                <a:ext cx="4308709" cy="2389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ja-JP" sz="5512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Erlotinib  0       </a:t>
                </a:r>
                <a:r>
                  <a:rPr lang="ja-JP" altLang="en-US" sz="5512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　</a:t>
                </a:r>
                <a:r>
                  <a:rPr lang="en-US" altLang="ja-JP" sz="5512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1          10       100      1000     10000 (nM)</a:t>
                </a:r>
                <a:endParaRPr lang="ja-JP" altLang="en-US" sz="5512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  <p:pic>
            <p:nvPicPr>
              <p:cNvPr id="19478" name="Picture 2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62" b="16254"/>
              <a:stretch>
                <a:fillRect/>
              </a:stretch>
            </p:blipFill>
            <p:spPr bwMode="auto">
              <a:xfrm>
                <a:off x="2192587" y="-111686"/>
                <a:ext cx="1836490" cy="31596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479" name="AutoShape 2"/>
              <p:cNvSpPr>
                <a:spLocks noChangeAspect="1" noChangeArrowheads="1"/>
              </p:cNvSpPr>
              <p:nvPr/>
            </p:nvSpPr>
            <p:spPr bwMode="auto">
              <a:xfrm>
                <a:off x="100013" y="476250"/>
                <a:ext cx="3629025" cy="30289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lang="ja-JP" altLang="en-US" sz="28697">
                  <a:solidFill>
                    <a:srgbClr val="000000"/>
                  </a:solidFill>
                  <a:ea typeface="ＭＳ Ｐゴシック" pitchFamily="50" charset="-128"/>
                </a:endParaRPr>
              </a:p>
            </p:txBody>
          </p:sp>
          <p:pic>
            <p:nvPicPr>
              <p:cNvPr id="19480" name="Picture 3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15013" y="5172075"/>
                <a:ext cx="3024187" cy="3905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6" name="テキスト ボックス 3"/>
              <p:cNvSpPr txBox="1">
                <a:spLocks noChangeArrowheads="1"/>
              </p:cNvSpPr>
              <p:nvPr/>
            </p:nvSpPr>
            <p:spPr bwMode="auto">
              <a:xfrm>
                <a:off x="4752975" y="2815221"/>
                <a:ext cx="970357" cy="2697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1" lang="en-US" altLang="ja-JP" sz="6299" dirty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N</a:t>
                </a:r>
                <a:r>
                  <a:rPr kumimoji="1" lang="en-US" altLang="ja-JP" sz="6299" dirty="0" smtClean="0">
                    <a:solidFill>
                      <a:srgbClr val="000000"/>
                    </a:solidFill>
                    <a:latin typeface="Times New Roman" pitchFamily="18" charset="0"/>
                    <a:ea typeface="ＭＳ Ｐゴシック" pitchFamily="50" charset="-128"/>
                    <a:cs typeface="Times New Roman" pitchFamily="18" charset="0"/>
                  </a:rPr>
                  <a:t>-cadherin</a:t>
                </a:r>
                <a:endParaRPr kumimoji="1" lang="en-US" altLang="ja-JP" sz="5512" dirty="0">
                  <a:solidFill>
                    <a:srgbClr val="000000"/>
                  </a:solidFill>
                  <a:latin typeface="Times New Roman" pitchFamily="18" charset="0"/>
                  <a:ea typeface="ＭＳ Ｐゴシック" pitchFamily="50" charset="-128"/>
                  <a:cs typeface="Times New Roman" pitchFamily="18" charset="0"/>
                </a:endParaRPr>
              </a:p>
            </p:txBody>
          </p:sp>
        </p:grpSp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8"/>
            <a:srcRect b="16840"/>
            <a:stretch/>
          </p:blipFill>
          <p:spPr>
            <a:xfrm>
              <a:off x="1083469" y="11885612"/>
              <a:ext cx="15849600" cy="11811000"/>
            </a:xfrm>
            <a:prstGeom prst="rect">
              <a:avLst/>
            </a:prstGeom>
          </p:spPr>
        </p:pic>
        <p:pic>
          <p:nvPicPr>
            <p:cNvPr id="25" name="図 24"/>
            <p:cNvPicPr>
              <a:picLocks noChangeAspect="1"/>
            </p:cNvPicPr>
            <p:nvPr/>
          </p:nvPicPr>
          <p:blipFill rotWithShape="1">
            <a:blip r:embed="rId9" cstate="print">
              <a:duotone>
                <a:prstClr val="black"/>
                <a:schemeClr val="bg1">
                  <a:lumMod val="85000"/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48" r="44616"/>
            <a:stretch/>
          </p:blipFill>
          <p:spPr>
            <a:xfrm>
              <a:off x="23257669" y="13456789"/>
              <a:ext cx="11957017" cy="231502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37201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0</Words>
  <Application>Microsoft Office PowerPoint</Application>
  <PresentationFormat>ユーザー設定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Times New Roman</vt:lpstr>
      <vt:lpstr>Default Design</vt:lpstr>
      <vt:lpstr>PowerPoint プレゼンテーション</vt:lpstr>
    </vt:vector>
  </TitlesOfParts>
  <Company>H. Lee Moffitt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ilton, Rasa G.</dc:creator>
  <cp:lastModifiedBy>吉田健史</cp:lastModifiedBy>
  <cp:revision>6</cp:revision>
  <dcterms:created xsi:type="dcterms:W3CDTF">2014-12-16T20:44:21Z</dcterms:created>
  <dcterms:modified xsi:type="dcterms:W3CDTF">2015-08-30T15:18:41Z</dcterms:modified>
</cp:coreProperties>
</file>